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32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447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5857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675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343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298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315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339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183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5334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89974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32C77B-EC67-438D-AE4B-E956DA0FA9A2}" type="datetimeFigureOut">
              <a:rPr lang="en-US" smtClean="0"/>
              <a:t>11/1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5B7882-4263-4281-A72B-A20CFB1170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74432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217" y="1643062"/>
            <a:ext cx="10906125" cy="357187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820177" y="5173597"/>
            <a:ext cx="10841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2. Gating strategy for JC-1 </a:t>
            </a:r>
            <a:r>
              <a:rPr lang="en-US" dirty="0" smtClean="0"/>
              <a:t>Analysis.  FSC = Forward Scatter, SSC = Side Scatter, JC1 = JC-1 stain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977288" y="3121222"/>
            <a:ext cx="8499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75.1%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0028336" y="3191326"/>
            <a:ext cx="5146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52%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0634472" y="3572326"/>
            <a:ext cx="68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50.4%</a:t>
            </a:r>
            <a:endParaRPr lang="en-US" sz="1400" b="1" dirty="0"/>
          </a:p>
        </p:txBody>
      </p:sp>
      <p:sp>
        <p:nvSpPr>
          <p:cNvPr id="7" name="Right Arrow 6"/>
          <p:cNvSpPr/>
          <p:nvPr/>
        </p:nvSpPr>
        <p:spPr>
          <a:xfrm>
            <a:off x="4154614" y="3127246"/>
            <a:ext cx="353378" cy="371857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ight Arrow 8"/>
          <p:cNvSpPr/>
          <p:nvPr/>
        </p:nvSpPr>
        <p:spPr>
          <a:xfrm>
            <a:off x="7777352" y="3121222"/>
            <a:ext cx="353378" cy="371857"/>
          </a:xfrm>
          <a:prstGeom prst="rightArrow">
            <a:avLst/>
          </a:prstGeom>
          <a:solidFill>
            <a:schemeClr val="tx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299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30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cTernan, Patrick</dc:creator>
  <cp:lastModifiedBy>McTernan, Patrick</cp:lastModifiedBy>
  <cp:revision>7</cp:revision>
  <dcterms:created xsi:type="dcterms:W3CDTF">2020-05-21T15:38:18Z</dcterms:created>
  <dcterms:modified xsi:type="dcterms:W3CDTF">2020-11-12T19:56:29Z</dcterms:modified>
</cp:coreProperties>
</file>